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webextensions/taskpanes.xml" ContentType="application/vnd.ms-office.webextensiontaskpanes+xml"/>
  <Override PartName="/ppt/webextensions/webextension1.xml" ContentType="application/vnd.ms-office.webextension+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thumbnail" Target="docProps/thumbnail.jpeg"/><Relationship Id="rId2" Type="http://schemas.openxmlformats.org/officeDocument/2006/relationships/officeDocument" Target="ppt/presentation.xml"/><Relationship Id="rId1" Type="http://schemas.microsoft.com/office/2011/relationships/webextensiontaskpanes" Target="ppt/webextensions/taskpanes.xml"/><Relationship Id="rId6" Type="http://schemas.openxmlformats.org/officeDocument/2006/relationships/custom-properties" Target="docProps/custom.xml"/><Relationship Id="rId5" Type="http://schemas.openxmlformats.org/officeDocument/2006/relationships/extended-properties" Target="docProps/app.xml"/><Relationship Id="rId4" Type="http://schemas.openxmlformats.org/package/2006/relationships/metadata/core-properties" Target="docProps/core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4"/>
  </p:sldMasterIdLst>
  <p:notesMasterIdLst>
    <p:notesMasterId r:id="rId6"/>
  </p:notesMasterIdLst>
  <p:sldIdLst>
    <p:sldId id="271" r:id="rId5"/>
  </p:sldIdLst>
  <p:sldSz cx="6264275" cy="5486400"/>
  <p:notesSz cx="6858000" cy="931386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E3ECC"/>
    <a:srgbClr val="FF0000"/>
    <a:srgbClr val="E885E8"/>
    <a:srgbClr val="33CC33"/>
    <a:srgbClr val="23E1E1"/>
    <a:srgbClr val="34FF34"/>
    <a:srgbClr val="B9B9B9"/>
    <a:srgbClr val="939318"/>
    <a:srgbClr val="E32928"/>
    <a:srgbClr val="00C5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49" autoAdjust="0"/>
    <p:restoredTop sz="96279" autoAdjust="0"/>
  </p:normalViewPr>
  <p:slideViewPr>
    <p:cSldViewPr snapToGrid="0">
      <p:cViewPr varScale="1">
        <p:scale>
          <a:sx n="108" d="100"/>
          <a:sy n="108" d="100"/>
        </p:scale>
        <p:origin x="210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awrence, C Martin" userId="a1c56794-96be-4b4e-97be-4659eef358cd" providerId="ADAL" clId="{04B6B382-D8C8-4ECC-8128-A83B787E1F1F}"/>
    <pc:docChg chg="modSld">
      <pc:chgData name="Lawrence, C Martin" userId="a1c56794-96be-4b4e-97be-4659eef358cd" providerId="ADAL" clId="{04B6B382-D8C8-4ECC-8128-A83B787E1F1F}" dt="2025-06-25T16:56:53.756" v="1" actId="20577"/>
      <pc:docMkLst>
        <pc:docMk/>
      </pc:docMkLst>
      <pc:sldChg chg="modSp mod">
        <pc:chgData name="Lawrence, C Martin" userId="a1c56794-96be-4b4e-97be-4659eef358cd" providerId="ADAL" clId="{04B6B382-D8C8-4ECC-8128-A83B787E1F1F}" dt="2025-06-25T16:56:53.756" v="1" actId="20577"/>
        <pc:sldMkLst>
          <pc:docMk/>
          <pc:sldMk cId="3645400332" sldId="271"/>
        </pc:sldMkLst>
        <pc:spChg chg="mod">
          <ac:chgData name="Lawrence, C Martin" userId="a1c56794-96be-4b4e-97be-4659eef358cd" providerId="ADAL" clId="{04B6B382-D8C8-4ECC-8128-A83B787E1F1F}" dt="2025-06-25T16:56:49.296" v="0" actId="20577"/>
          <ac:spMkLst>
            <pc:docMk/>
            <pc:sldMk cId="3645400332" sldId="271"/>
            <ac:spMk id="14" creationId="{FC644567-78EA-D902-5F6F-32FC32F97967}"/>
          </ac:spMkLst>
        </pc:spChg>
        <pc:spChg chg="mod">
          <ac:chgData name="Lawrence, C Martin" userId="a1c56794-96be-4b4e-97be-4659eef358cd" providerId="ADAL" clId="{04B6B382-D8C8-4ECC-8128-A83B787E1F1F}" dt="2025-06-25T16:56:53.756" v="1" actId="20577"/>
          <ac:spMkLst>
            <pc:docMk/>
            <pc:sldMk cId="3645400332" sldId="271"/>
            <ac:spMk id="24" creationId="{4C0432D2-7156-E734-EA46-EA5DD0CFD4F1}"/>
          </ac:spMkLst>
        </pc:spChg>
      </pc:sldChg>
    </pc:docChg>
  </pc:docChgLst>
  <pc:docChgLst>
    <pc:chgData name="Lawrence, C Martin" userId="a1c56794-96be-4b4e-97be-4659eef358cd" providerId="ADAL" clId="{702A9C86-412E-42C5-ABD1-2821F33EE944}"/>
    <pc:docChg chg="undo custSel delSld modSld">
      <pc:chgData name="Lawrence, C Martin" userId="a1c56794-96be-4b4e-97be-4659eef358cd" providerId="ADAL" clId="{702A9C86-412E-42C5-ABD1-2821F33EE944}" dt="2025-07-09T14:24:42.606" v="45" actId="1038"/>
      <pc:docMkLst>
        <pc:docMk/>
      </pc:docMkLst>
      <pc:sldChg chg="addSp modSp mod modAnim">
        <pc:chgData name="Lawrence, C Martin" userId="a1c56794-96be-4b4e-97be-4659eef358cd" providerId="ADAL" clId="{702A9C86-412E-42C5-ABD1-2821F33EE944}" dt="2025-07-09T14:24:42.606" v="45" actId="1038"/>
        <pc:sldMkLst>
          <pc:docMk/>
          <pc:sldMk cId="3645400332" sldId="271"/>
        </pc:sldMkLst>
        <pc:spChg chg="mod">
          <ac:chgData name="Lawrence, C Martin" userId="a1c56794-96be-4b4e-97be-4659eef358cd" providerId="ADAL" clId="{702A9C86-412E-42C5-ABD1-2821F33EE944}" dt="2025-07-09T14:23:18.844" v="3" actId="164"/>
          <ac:spMkLst>
            <pc:docMk/>
            <pc:sldMk cId="3645400332" sldId="271"/>
            <ac:spMk id="6" creationId="{274872F4-3EE6-E41E-6339-EE49855BE465}"/>
          </ac:spMkLst>
        </pc:spChg>
        <pc:spChg chg="mod">
          <ac:chgData name="Lawrence, C Martin" userId="a1c56794-96be-4b4e-97be-4659eef358cd" providerId="ADAL" clId="{702A9C86-412E-42C5-ABD1-2821F33EE944}" dt="2025-07-09T14:23:18.844" v="3" actId="164"/>
          <ac:spMkLst>
            <pc:docMk/>
            <pc:sldMk cId="3645400332" sldId="271"/>
            <ac:spMk id="9" creationId="{9FF45205-30D5-C8F4-1E91-FFF76DF86BE3}"/>
          </ac:spMkLst>
        </pc:spChg>
        <pc:spChg chg="mod">
          <ac:chgData name="Lawrence, C Martin" userId="a1c56794-96be-4b4e-97be-4659eef358cd" providerId="ADAL" clId="{702A9C86-412E-42C5-ABD1-2821F33EE944}" dt="2025-07-09T14:23:18.844" v="3" actId="164"/>
          <ac:spMkLst>
            <pc:docMk/>
            <pc:sldMk cId="3645400332" sldId="271"/>
            <ac:spMk id="11" creationId="{E6ED3F63-53C4-27C7-0B00-CBB95C81217A}"/>
          </ac:spMkLst>
        </pc:spChg>
        <pc:spChg chg="mod">
          <ac:chgData name="Lawrence, C Martin" userId="a1c56794-96be-4b4e-97be-4659eef358cd" providerId="ADAL" clId="{702A9C86-412E-42C5-ABD1-2821F33EE944}" dt="2025-07-09T14:23:18.844" v="3" actId="164"/>
          <ac:spMkLst>
            <pc:docMk/>
            <pc:sldMk cId="3645400332" sldId="271"/>
            <ac:spMk id="18" creationId="{69501779-9026-1E2C-72FA-5D1176E45E0A}"/>
          </ac:spMkLst>
        </pc:spChg>
        <pc:spChg chg="mod">
          <ac:chgData name="Lawrence, C Martin" userId="a1c56794-96be-4b4e-97be-4659eef358cd" providerId="ADAL" clId="{702A9C86-412E-42C5-ABD1-2821F33EE944}" dt="2025-07-09T14:23:18.844" v="3" actId="164"/>
          <ac:spMkLst>
            <pc:docMk/>
            <pc:sldMk cId="3645400332" sldId="271"/>
            <ac:spMk id="19" creationId="{606E61A0-7C41-114C-9D2E-F3F9650FC833}"/>
          </ac:spMkLst>
        </pc:spChg>
        <pc:spChg chg="mod">
          <ac:chgData name="Lawrence, C Martin" userId="a1c56794-96be-4b4e-97be-4659eef358cd" providerId="ADAL" clId="{702A9C86-412E-42C5-ABD1-2821F33EE944}" dt="2025-07-09T14:23:18.844" v="3" actId="164"/>
          <ac:spMkLst>
            <pc:docMk/>
            <pc:sldMk cId="3645400332" sldId="271"/>
            <ac:spMk id="21" creationId="{788BAC48-302A-FBC1-56FE-F70CD40CB90E}"/>
          </ac:spMkLst>
        </pc:spChg>
        <pc:spChg chg="mod">
          <ac:chgData name="Lawrence, C Martin" userId="a1c56794-96be-4b4e-97be-4659eef358cd" providerId="ADAL" clId="{702A9C86-412E-42C5-ABD1-2821F33EE944}" dt="2025-07-09T14:23:18.844" v="3" actId="164"/>
          <ac:spMkLst>
            <pc:docMk/>
            <pc:sldMk cId="3645400332" sldId="271"/>
            <ac:spMk id="23" creationId="{A4897AA0-70D5-9B89-2431-80837C132FCA}"/>
          </ac:spMkLst>
        </pc:spChg>
        <pc:spChg chg="mod">
          <ac:chgData name="Lawrence, C Martin" userId="a1c56794-96be-4b4e-97be-4659eef358cd" providerId="ADAL" clId="{702A9C86-412E-42C5-ABD1-2821F33EE944}" dt="2025-07-09T14:23:18.844" v="3" actId="164"/>
          <ac:spMkLst>
            <pc:docMk/>
            <pc:sldMk cId="3645400332" sldId="271"/>
            <ac:spMk id="36" creationId="{9205EBFE-EF1C-CE19-CCBC-A717978929A1}"/>
          </ac:spMkLst>
        </pc:spChg>
        <pc:spChg chg="mod">
          <ac:chgData name="Lawrence, C Martin" userId="a1c56794-96be-4b4e-97be-4659eef358cd" providerId="ADAL" clId="{702A9C86-412E-42C5-ABD1-2821F33EE944}" dt="2025-07-09T14:23:18.844" v="3" actId="164"/>
          <ac:spMkLst>
            <pc:docMk/>
            <pc:sldMk cId="3645400332" sldId="271"/>
            <ac:spMk id="308" creationId="{DA77CD65-C53C-AB94-D18D-E70958DA1B78}"/>
          </ac:spMkLst>
        </pc:spChg>
        <pc:spChg chg="mod">
          <ac:chgData name="Lawrence, C Martin" userId="a1c56794-96be-4b4e-97be-4659eef358cd" providerId="ADAL" clId="{702A9C86-412E-42C5-ABD1-2821F33EE944}" dt="2025-07-09T14:23:18.844" v="3" actId="164"/>
          <ac:spMkLst>
            <pc:docMk/>
            <pc:sldMk cId="3645400332" sldId="271"/>
            <ac:spMk id="309" creationId="{5843C707-0D3B-C5DC-73DB-800AFBE2A5FA}"/>
          </ac:spMkLst>
        </pc:spChg>
        <pc:grpChg chg="mod">
          <ac:chgData name="Lawrence, C Martin" userId="a1c56794-96be-4b4e-97be-4659eef358cd" providerId="ADAL" clId="{702A9C86-412E-42C5-ABD1-2821F33EE944}" dt="2025-07-09T14:24:42.606" v="45" actId="1038"/>
          <ac:grpSpMkLst>
            <pc:docMk/>
            <pc:sldMk cId="3645400332" sldId="271"/>
            <ac:grpSpMk id="33" creationId="{7892DB60-1E70-8D75-719E-47324EC3E0A6}"/>
          </ac:grpSpMkLst>
        </pc:grpChg>
      </pc:sldChg>
      <pc:sldChg chg="del">
        <pc:chgData name="Lawrence, C Martin" userId="a1c56794-96be-4b4e-97be-4659eef358cd" providerId="ADAL" clId="{702A9C86-412E-42C5-ABD1-2821F33EE944}" dt="2025-07-09T14:21:32.972" v="0" actId="47"/>
        <pc:sldMkLst>
          <pc:docMk/>
          <pc:sldMk cId="2969857098" sldId="272"/>
        </pc:sldMkLst>
      </pc:sldChg>
    </pc:docChg>
  </pc:docChgLst>
  <pc:docChgLst>
    <pc:chgData name="DuBois, Jennifer" userId="fc8f9eb0-3f8f-46ae-af8b-fd777331bb29" providerId="ADAL" clId="{3B2EB6F1-1A9E-45C7-955E-4887E289443E}"/>
    <pc:docChg chg="undo custSel delSld modSld">
      <pc:chgData name="DuBois, Jennifer" userId="fc8f9eb0-3f8f-46ae-af8b-fd777331bb29" providerId="ADAL" clId="{3B2EB6F1-1A9E-45C7-955E-4887E289443E}" dt="2024-11-28T08:23:56.614" v="2930" actId="1038"/>
      <pc:docMkLst>
        <pc:docMk/>
      </pc:docMkLst>
      <pc:sldChg chg="addSp delSp modSp mod modAnim">
        <pc:chgData name="DuBois, Jennifer" userId="fc8f9eb0-3f8f-46ae-af8b-fd777331bb29" providerId="ADAL" clId="{3B2EB6F1-1A9E-45C7-955E-4887E289443E}" dt="2024-11-28T08:23:56.614" v="2930" actId="1038"/>
        <pc:sldMkLst>
          <pc:docMk/>
          <pc:sldMk cId="3645400332" sldId="271"/>
        </pc:sldMkLst>
      </pc:sldChg>
      <pc:sldChg chg="del">
        <pc:chgData name="DuBois, Jennifer" userId="fc8f9eb0-3f8f-46ae-af8b-fd777331bb29" providerId="ADAL" clId="{3B2EB6F1-1A9E-45C7-955E-4887E289443E}" dt="2024-11-26T20:20:55.686" v="2858" actId="47"/>
        <pc:sldMkLst>
          <pc:docMk/>
          <pc:sldMk cId="1143786557" sldId="273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71800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4" y="0"/>
            <a:ext cx="2971800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398B518-4272-4621-B73D-CD3FD3B7020D}" type="datetimeFigureOut">
              <a:rPr lang="en-US" smtClean="0"/>
              <a:t>7/9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635125" y="1163638"/>
            <a:ext cx="3587750" cy="31432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81514"/>
            <a:ext cx="5486400" cy="36687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8847139"/>
            <a:ext cx="2971800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4" y="8847139"/>
            <a:ext cx="2971800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98F3161-4536-43BA-B8B9-C3D0B1FD71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73591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635125" y="1163638"/>
            <a:ext cx="3587750" cy="31432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98F3161-4536-43BA-B8B9-C3D0B1FD71E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57704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9821" y="897890"/>
            <a:ext cx="5324634" cy="1910080"/>
          </a:xfrm>
        </p:spPr>
        <p:txBody>
          <a:bodyPr anchor="b"/>
          <a:lstStyle>
            <a:lvl1pPr algn="ctr">
              <a:defRPr sz="411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83035" y="2881630"/>
            <a:ext cx="4698206" cy="1324610"/>
          </a:xfrm>
        </p:spPr>
        <p:txBody>
          <a:bodyPr/>
          <a:lstStyle>
            <a:lvl1pPr marL="0" indent="0" algn="ctr">
              <a:buNone/>
              <a:defRPr sz="1644"/>
            </a:lvl1pPr>
            <a:lvl2pPr marL="313228" indent="0" algn="ctr">
              <a:buNone/>
              <a:defRPr sz="1370"/>
            </a:lvl2pPr>
            <a:lvl3pPr marL="626455" indent="0" algn="ctr">
              <a:buNone/>
              <a:defRPr sz="1233"/>
            </a:lvl3pPr>
            <a:lvl4pPr marL="939683" indent="0" algn="ctr">
              <a:buNone/>
              <a:defRPr sz="1096"/>
            </a:lvl4pPr>
            <a:lvl5pPr marL="1252911" indent="0" algn="ctr">
              <a:buNone/>
              <a:defRPr sz="1096"/>
            </a:lvl5pPr>
            <a:lvl6pPr marL="1566139" indent="0" algn="ctr">
              <a:buNone/>
              <a:defRPr sz="1096"/>
            </a:lvl6pPr>
            <a:lvl7pPr marL="1879366" indent="0" algn="ctr">
              <a:buNone/>
              <a:defRPr sz="1096"/>
            </a:lvl7pPr>
            <a:lvl8pPr marL="2192594" indent="0" algn="ctr">
              <a:buNone/>
              <a:defRPr sz="1096"/>
            </a:lvl8pPr>
            <a:lvl9pPr marL="2505822" indent="0" algn="ctr">
              <a:buNone/>
              <a:defRPr sz="1096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3524A-635E-4CC4-BA4C-753BC5EAA9DE}" type="datetimeFigureOut">
              <a:rPr lang="en-US" smtClean="0"/>
              <a:t>7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A97F1E-0839-4902-AFBC-78593FD9C2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25034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3524A-635E-4CC4-BA4C-753BC5EAA9DE}" type="datetimeFigureOut">
              <a:rPr lang="en-US" smtClean="0"/>
              <a:t>7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A97F1E-0839-4902-AFBC-78593FD9C2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08920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482872" y="292100"/>
            <a:ext cx="1350734" cy="464947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30669" y="292100"/>
            <a:ext cx="3973899" cy="464947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3524A-635E-4CC4-BA4C-753BC5EAA9DE}" type="datetimeFigureOut">
              <a:rPr lang="en-US" smtClean="0"/>
              <a:t>7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A97F1E-0839-4902-AFBC-78593FD9C2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65267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3524A-635E-4CC4-BA4C-753BC5EAA9DE}" type="datetimeFigureOut">
              <a:rPr lang="en-US" smtClean="0"/>
              <a:t>7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A97F1E-0839-4902-AFBC-78593FD9C2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54993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7407" y="1367791"/>
            <a:ext cx="5402937" cy="2282190"/>
          </a:xfrm>
        </p:spPr>
        <p:txBody>
          <a:bodyPr anchor="b"/>
          <a:lstStyle>
            <a:lvl1pPr>
              <a:defRPr sz="411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7407" y="3671571"/>
            <a:ext cx="5402937" cy="1200150"/>
          </a:xfrm>
        </p:spPr>
        <p:txBody>
          <a:bodyPr/>
          <a:lstStyle>
            <a:lvl1pPr marL="0" indent="0">
              <a:buNone/>
              <a:defRPr sz="1644">
                <a:solidFill>
                  <a:schemeClr val="tx1"/>
                </a:solidFill>
              </a:defRPr>
            </a:lvl1pPr>
            <a:lvl2pPr marL="313228" indent="0">
              <a:buNone/>
              <a:defRPr sz="1370">
                <a:solidFill>
                  <a:schemeClr val="tx1">
                    <a:tint val="75000"/>
                  </a:schemeClr>
                </a:solidFill>
              </a:defRPr>
            </a:lvl2pPr>
            <a:lvl3pPr marL="626455" indent="0">
              <a:buNone/>
              <a:defRPr sz="1233">
                <a:solidFill>
                  <a:schemeClr val="tx1">
                    <a:tint val="75000"/>
                  </a:schemeClr>
                </a:solidFill>
              </a:defRPr>
            </a:lvl3pPr>
            <a:lvl4pPr marL="939683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4pPr>
            <a:lvl5pPr marL="1252911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5pPr>
            <a:lvl6pPr marL="1566139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6pPr>
            <a:lvl7pPr marL="1879366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7pPr>
            <a:lvl8pPr marL="2192594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8pPr>
            <a:lvl9pPr marL="2505822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3524A-635E-4CC4-BA4C-753BC5EAA9DE}" type="datetimeFigureOut">
              <a:rPr lang="en-US" smtClean="0"/>
              <a:t>7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A97F1E-0839-4902-AFBC-78593FD9C2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93476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30669" y="1460500"/>
            <a:ext cx="2662317" cy="348107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71289" y="1460500"/>
            <a:ext cx="2662317" cy="348107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3524A-635E-4CC4-BA4C-753BC5EAA9DE}" type="datetimeFigureOut">
              <a:rPr lang="en-US" smtClean="0"/>
              <a:t>7/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A97F1E-0839-4902-AFBC-78593FD9C2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70127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292101"/>
            <a:ext cx="5402937" cy="1060450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1485" y="1344930"/>
            <a:ext cx="2650082" cy="659130"/>
          </a:xfrm>
        </p:spPr>
        <p:txBody>
          <a:bodyPr anchor="b"/>
          <a:lstStyle>
            <a:lvl1pPr marL="0" indent="0">
              <a:buNone/>
              <a:defRPr sz="1644" b="1"/>
            </a:lvl1pPr>
            <a:lvl2pPr marL="313228" indent="0">
              <a:buNone/>
              <a:defRPr sz="1370" b="1"/>
            </a:lvl2pPr>
            <a:lvl3pPr marL="626455" indent="0">
              <a:buNone/>
              <a:defRPr sz="1233" b="1"/>
            </a:lvl3pPr>
            <a:lvl4pPr marL="939683" indent="0">
              <a:buNone/>
              <a:defRPr sz="1096" b="1"/>
            </a:lvl4pPr>
            <a:lvl5pPr marL="1252911" indent="0">
              <a:buNone/>
              <a:defRPr sz="1096" b="1"/>
            </a:lvl5pPr>
            <a:lvl6pPr marL="1566139" indent="0">
              <a:buNone/>
              <a:defRPr sz="1096" b="1"/>
            </a:lvl6pPr>
            <a:lvl7pPr marL="1879366" indent="0">
              <a:buNone/>
              <a:defRPr sz="1096" b="1"/>
            </a:lvl7pPr>
            <a:lvl8pPr marL="2192594" indent="0">
              <a:buNone/>
              <a:defRPr sz="1096" b="1"/>
            </a:lvl8pPr>
            <a:lvl9pPr marL="2505822" indent="0">
              <a:buNone/>
              <a:defRPr sz="109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1485" y="2004060"/>
            <a:ext cx="2650082" cy="294767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71289" y="1344930"/>
            <a:ext cx="2663133" cy="659130"/>
          </a:xfrm>
        </p:spPr>
        <p:txBody>
          <a:bodyPr anchor="b"/>
          <a:lstStyle>
            <a:lvl1pPr marL="0" indent="0">
              <a:buNone/>
              <a:defRPr sz="1644" b="1"/>
            </a:lvl1pPr>
            <a:lvl2pPr marL="313228" indent="0">
              <a:buNone/>
              <a:defRPr sz="1370" b="1"/>
            </a:lvl2pPr>
            <a:lvl3pPr marL="626455" indent="0">
              <a:buNone/>
              <a:defRPr sz="1233" b="1"/>
            </a:lvl3pPr>
            <a:lvl4pPr marL="939683" indent="0">
              <a:buNone/>
              <a:defRPr sz="1096" b="1"/>
            </a:lvl4pPr>
            <a:lvl5pPr marL="1252911" indent="0">
              <a:buNone/>
              <a:defRPr sz="1096" b="1"/>
            </a:lvl5pPr>
            <a:lvl6pPr marL="1566139" indent="0">
              <a:buNone/>
              <a:defRPr sz="1096" b="1"/>
            </a:lvl6pPr>
            <a:lvl7pPr marL="1879366" indent="0">
              <a:buNone/>
              <a:defRPr sz="1096" b="1"/>
            </a:lvl7pPr>
            <a:lvl8pPr marL="2192594" indent="0">
              <a:buNone/>
              <a:defRPr sz="1096" b="1"/>
            </a:lvl8pPr>
            <a:lvl9pPr marL="2505822" indent="0">
              <a:buNone/>
              <a:defRPr sz="109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71289" y="2004060"/>
            <a:ext cx="2663133" cy="294767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3524A-635E-4CC4-BA4C-753BC5EAA9DE}" type="datetimeFigureOut">
              <a:rPr lang="en-US" smtClean="0"/>
              <a:t>7/9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A97F1E-0839-4902-AFBC-78593FD9C2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7993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3524A-635E-4CC4-BA4C-753BC5EAA9DE}" type="datetimeFigureOut">
              <a:rPr lang="en-US" smtClean="0"/>
              <a:t>7/9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A97F1E-0839-4902-AFBC-78593FD9C2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34384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3524A-635E-4CC4-BA4C-753BC5EAA9DE}" type="datetimeFigureOut">
              <a:rPr lang="en-US" smtClean="0"/>
              <a:t>7/9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A97F1E-0839-4902-AFBC-78593FD9C2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2077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365760"/>
            <a:ext cx="2020392" cy="1280160"/>
          </a:xfrm>
        </p:spPr>
        <p:txBody>
          <a:bodyPr anchor="b"/>
          <a:lstStyle>
            <a:lvl1pPr>
              <a:defRPr sz="219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63133" y="789941"/>
            <a:ext cx="3171289" cy="3898900"/>
          </a:xfrm>
        </p:spPr>
        <p:txBody>
          <a:bodyPr/>
          <a:lstStyle>
            <a:lvl1pPr>
              <a:defRPr sz="2192"/>
            </a:lvl1pPr>
            <a:lvl2pPr>
              <a:defRPr sz="1918"/>
            </a:lvl2pPr>
            <a:lvl3pPr>
              <a:defRPr sz="1644"/>
            </a:lvl3pPr>
            <a:lvl4pPr>
              <a:defRPr sz="1370"/>
            </a:lvl4pPr>
            <a:lvl5pPr>
              <a:defRPr sz="1370"/>
            </a:lvl5pPr>
            <a:lvl6pPr>
              <a:defRPr sz="1370"/>
            </a:lvl6pPr>
            <a:lvl7pPr>
              <a:defRPr sz="1370"/>
            </a:lvl7pPr>
            <a:lvl8pPr>
              <a:defRPr sz="1370"/>
            </a:lvl8pPr>
            <a:lvl9pPr>
              <a:defRPr sz="137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1485" y="1645920"/>
            <a:ext cx="2020392" cy="3049270"/>
          </a:xfrm>
        </p:spPr>
        <p:txBody>
          <a:bodyPr/>
          <a:lstStyle>
            <a:lvl1pPr marL="0" indent="0">
              <a:buNone/>
              <a:defRPr sz="1096"/>
            </a:lvl1pPr>
            <a:lvl2pPr marL="313228" indent="0">
              <a:buNone/>
              <a:defRPr sz="959"/>
            </a:lvl2pPr>
            <a:lvl3pPr marL="626455" indent="0">
              <a:buNone/>
              <a:defRPr sz="822"/>
            </a:lvl3pPr>
            <a:lvl4pPr marL="939683" indent="0">
              <a:buNone/>
              <a:defRPr sz="685"/>
            </a:lvl4pPr>
            <a:lvl5pPr marL="1252911" indent="0">
              <a:buNone/>
              <a:defRPr sz="685"/>
            </a:lvl5pPr>
            <a:lvl6pPr marL="1566139" indent="0">
              <a:buNone/>
              <a:defRPr sz="685"/>
            </a:lvl6pPr>
            <a:lvl7pPr marL="1879366" indent="0">
              <a:buNone/>
              <a:defRPr sz="685"/>
            </a:lvl7pPr>
            <a:lvl8pPr marL="2192594" indent="0">
              <a:buNone/>
              <a:defRPr sz="685"/>
            </a:lvl8pPr>
            <a:lvl9pPr marL="2505822" indent="0">
              <a:buNone/>
              <a:defRPr sz="68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3524A-635E-4CC4-BA4C-753BC5EAA9DE}" type="datetimeFigureOut">
              <a:rPr lang="en-US" smtClean="0"/>
              <a:t>7/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A97F1E-0839-4902-AFBC-78593FD9C2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38851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365760"/>
            <a:ext cx="2020392" cy="1280160"/>
          </a:xfrm>
        </p:spPr>
        <p:txBody>
          <a:bodyPr anchor="b"/>
          <a:lstStyle>
            <a:lvl1pPr>
              <a:defRPr sz="219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63133" y="789941"/>
            <a:ext cx="3171289" cy="3898900"/>
          </a:xfrm>
        </p:spPr>
        <p:txBody>
          <a:bodyPr anchor="t"/>
          <a:lstStyle>
            <a:lvl1pPr marL="0" indent="0">
              <a:buNone/>
              <a:defRPr sz="2192"/>
            </a:lvl1pPr>
            <a:lvl2pPr marL="313228" indent="0">
              <a:buNone/>
              <a:defRPr sz="1918"/>
            </a:lvl2pPr>
            <a:lvl3pPr marL="626455" indent="0">
              <a:buNone/>
              <a:defRPr sz="1644"/>
            </a:lvl3pPr>
            <a:lvl4pPr marL="939683" indent="0">
              <a:buNone/>
              <a:defRPr sz="1370"/>
            </a:lvl4pPr>
            <a:lvl5pPr marL="1252911" indent="0">
              <a:buNone/>
              <a:defRPr sz="1370"/>
            </a:lvl5pPr>
            <a:lvl6pPr marL="1566139" indent="0">
              <a:buNone/>
              <a:defRPr sz="1370"/>
            </a:lvl6pPr>
            <a:lvl7pPr marL="1879366" indent="0">
              <a:buNone/>
              <a:defRPr sz="1370"/>
            </a:lvl7pPr>
            <a:lvl8pPr marL="2192594" indent="0">
              <a:buNone/>
              <a:defRPr sz="1370"/>
            </a:lvl8pPr>
            <a:lvl9pPr marL="2505822" indent="0">
              <a:buNone/>
              <a:defRPr sz="137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1485" y="1645920"/>
            <a:ext cx="2020392" cy="3049270"/>
          </a:xfrm>
        </p:spPr>
        <p:txBody>
          <a:bodyPr/>
          <a:lstStyle>
            <a:lvl1pPr marL="0" indent="0">
              <a:buNone/>
              <a:defRPr sz="1096"/>
            </a:lvl1pPr>
            <a:lvl2pPr marL="313228" indent="0">
              <a:buNone/>
              <a:defRPr sz="959"/>
            </a:lvl2pPr>
            <a:lvl3pPr marL="626455" indent="0">
              <a:buNone/>
              <a:defRPr sz="822"/>
            </a:lvl3pPr>
            <a:lvl4pPr marL="939683" indent="0">
              <a:buNone/>
              <a:defRPr sz="685"/>
            </a:lvl4pPr>
            <a:lvl5pPr marL="1252911" indent="0">
              <a:buNone/>
              <a:defRPr sz="685"/>
            </a:lvl5pPr>
            <a:lvl6pPr marL="1566139" indent="0">
              <a:buNone/>
              <a:defRPr sz="685"/>
            </a:lvl6pPr>
            <a:lvl7pPr marL="1879366" indent="0">
              <a:buNone/>
              <a:defRPr sz="685"/>
            </a:lvl7pPr>
            <a:lvl8pPr marL="2192594" indent="0">
              <a:buNone/>
              <a:defRPr sz="685"/>
            </a:lvl8pPr>
            <a:lvl9pPr marL="2505822" indent="0">
              <a:buNone/>
              <a:defRPr sz="68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3524A-635E-4CC4-BA4C-753BC5EAA9DE}" type="datetimeFigureOut">
              <a:rPr lang="en-US" smtClean="0"/>
              <a:t>7/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A97F1E-0839-4902-AFBC-78593FD9C2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52101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30669" y="292101"/>
            <a:ext cx="5402937" cy="106045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0669" y="1460500"/>
            <a:ext cx="5402937" cy="348107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30669" y="5085081"/>
            <a:ext cx="1409462" cy="2921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93524A-635E-4CC4-BA4C-753BC5EAA9DE}" type="datetimeFigureOut">
              <a:rPr lang="en-US" smtClean="0"/>
              <a:t>7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75041" y="5085081"/>
            <a:ext cx="2114193" cy="2921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424144" y="5085081"/>
            <a:ext cx="1409462" cy="2921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A97F1E-0839-4902-AFBC-78593FD9C2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61161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26455" rtl="0" eaLnBrk="1" latinLnBrk="0" hangingPunct="1">
        <a:lnSpc>
          <a:spcPct val="90000"/>
        </a:lnSpc>
        <a:spcBef>
          <a:spcPct val="0"/>
        </a:spcBef>
        <a:buNone/>
        <a:defRPr sz="301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6614" indent="-156614" algn="l" defTabSz="626455" rtl="0" eaLnBrk="1" latinLnBrk="0" hangingPunct="1">
        <a:lnSpc>
          <a:spcPct val="90000"/>
        </a:lnSpc>
        <a:spcBef>
          <a:spcPts val="685"/>
        </a:spcBef>
        <a:buFont typeface="Arial" panose="020B0604020202020204" pitchFamily="34" charset="0"/>
        <a:buChar char="•"/>
        <a:defRPr sz="1918" kern="1200">
          <a:solidFill>
            <a:schemeClr val="tx1"/>
          </a:solidFill>
          <a:latin typeface="+mn-lt"/>
          <a:ea typeface="+mn-ea"/>
          <a:cs typeface="+mn-cs"/>
        </a:defRPr>
      </a:lvl1pPr>
      <a:lvl2pPr marL="469842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644" kern="1200">
          <a:solidFill>
            <a:schemeClr val="tx1"/>
          </a:solidFill>
          <a:latin typeface="+mn-lt"/>
          <a:ea typeface="+mn-ea"/>
          <a:cs typeface="+mn-cs"/>
        </a:defRPr>
      </a:lvl2pPr>
      <a:lvl3pPr marL="783069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370" kern="1200">
          <a:solidFill>
            <a:schemeClr val="tx1"/>
          </a:solidFill>
          <a:latin typeface="+mn-lt"/>
          <a:ea typeface="+mn-ea"/>
          <a:cs typeface="+mn-cs"/>
        </a:defRPr>
      </a:lvl3pPr>
      <a:lvl4pPr marL="1096297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4pPr>
      <a:lvl5pPr marL="1409525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5pPr>
      <a:lvl6pPr marL="1722752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6pPr>
      <a:lvl7pPr marL="2035980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7pPr>
      <a:lvl8pPr marL="2349208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8pPr>
      <a:lvl9pPr marL="2662436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1pPr>
      <a:lvl2pPr marL="313228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2pPr>
      <a:lvl3pPr marL="626455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3pPr>
      <a:lvl4pPr marL="939683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4pPr>
      <a:lvl5pPr marL="1252911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5pPr>
      <a:lvl6pPr marL="1566139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6pPr>
      <a:lvl7pPr marL="1879366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7pPr>
      <a:lvl8pPr marL="2192594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8pPr>
      <a:lvl9pPr marL="2505822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3" name="Group 32">
            <a:extLst>
              <a:ext uri="{FF2B5EF4-FFF2-40B4-BE49-F238E27FC236}">
                <a16:creationId xmlns:a16="http://schemas.microsoft.com/office/drawing/2014/main" id="{7892DB60-1E70-8D75-719E-47324EC3E0A6}"/>
              </a:ext>
            </a:extLst>
          </p:cNvPr>
          <p:cNvGrpSpPr/>
          <p:nvPr/>
        </p:nvGrpSpPr>
        <p:grpSpPr>
          <a:xfrm>
            <a:off x="-144822" y="-11406"/>
            <a:ext cx="6706424" cy="5477818"/>
            <a:chOff x="-144570" y="-1263772"/>
            <a:chExt cx="6706424" cy="5477818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E83158C3-B9A8-8433-6C64-A0B21DD12CD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t="5277" b="5277"/>
            <a:stretch/>
          </p:blipFill>
          <p:spPr>
            <a:xfrm>
              <a:off x="37121" y="-717649"/>
              <a:ext cx="3135679" cy="2039651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D459EF7D-AE7A-1C0E-C64C-A9E3691D4FF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t="3213" b="3213"/>
            <a:stretch/>
          </p:blipFill>
          <p:spPr>
            <a:xfrm>
              <a:off x="3148984" y="-763396"/>
              <a:ext cx="2996814" cy="2039294"/>
            </a:xfrm>
            <a:prstGeom prst="rect">
              <a:avLst/>
            </a:prstGeom>
          </p:spPr>
        </p:pic>
        <p:sp>
          <p:nvSpPr>
            <p:cNvPr id="121" name="Rectangle 120">
              <a:extLst>
                <a:ext uri="{FF2B5EF4-FFF2-40B4-BE49-F238E27FC236}">
                  <a16:creationId xmlns:a16="http://schemas.microsoft.com/office/drawing/2014/main" id="{314C0113-D70E-4A21-8776-E56D9579835A}"/>
                </a:ext>
              </a:extLst>
            </p:cNvPr>
            <p:cNvSpPr/>
            <p:nvPr/>
          </p:nvSpPr>
          <p:spPr>
            <a:xfrm>
              <a:off x="-15336" y="-1263772"/>
              <a:ext cx="263214" cy="2616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317" name="Rectangle 316">
              <a:extLst>
                <a:ext uri="{FF2B5EF4-FFF2-40B4-BE49-F238E27FC236}">
                  <a16:creationId xmlns:a16="http://schemas.microsoft.com/office/drawing/2014/main" id="{9171B723-FEF9-463B-93D5-3E6798D26689}"/>
                </a:ext>
              </a:extLst>
            </p:cNvPr>
            <p:cNvSpPr/>
            <p:nvPr/>
          </p:nvSpPr>
          <p:spPr>
            <a:xfrm>
              <a:off x="-15336" y="-793683"/>
              <a:ext cx="271228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318" name="Rectangle 317">
              <a:extLst>
                <a:ext uri="{FF2B5EF4-FFF2-40B4-BE49-F238E27FC236}">
                  <a16:creationId xmlns:a16="http://schemas.microsoft.com/office/drawing/2014/main" id="{B29349E6-955A-448F-BD99-C05B70F5C5A9}"/>
                </a:ext>
              </a:extLst>
            </p:cNvPr>
            <p:cNvSpPr/>
            <p:nvPr/>
          </p:nvSpPr>
          <p:spPr>
            <a:xfrm>
              <a:off x="3490431" y="-793683"/>
              <a:ext cx="263214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grpSp>
          <p:nvGrpSpPr>
            <p:cNvPr id="310" name="Group 309">
              <a:extLst>
                <a:ext uri="{FF2B5EF4-FFF2-40B4-BE49-F238E27FC236}">
                  <a16:creationId xmlns:a16="http://schemas.microsoft.com/office/drawing/2014/main" id="{B44A5277-3214-6410-330C-4DBAA52C40E7}"/>
                </a:ext>
              </a:extLst>
            </p:cNvPr>
            <p:cNvGrpSpPr/>
            <p:nvPr/>
          </p:nvGrpSpPr>
          <p:grpSpPr>
            <a:xfrm>
              <a:off x="2473841" y="-191646"/>
              <a:ext cx="906457" cy="661695"/>
              <a:chOff x="2510523" y="1200957"/>
              <a:chExt cx="906457" cy="661695"/>
            </a:xfrm>
          </p:grpSpPr>
          <p:cxnSp>
            <p:nvCxnSpPr>
              <p:cNvPr id="8" name="Straight Connector 7">
                <a:extLst>
                  <a:ext uri="{FF2B5EF4-FFF2-40B4-BE49-F238E27FC236}">
                    <a16:creationId xmlns:a16="http://schemas.microsoft.com/office/drawing/2014/main" id="{9A4C2628-7E85-989D-4304-7D70A98B7B6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867580" y="1574157"/>
                <a:ext cx="41190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" name="Arc 9">
                <a:extLst>
                  <a:ext uri="{FF2B5EF4-FFF2-40B4-BE49-F238E27FC236}">
                    <a16:creationId xmlns:a16="http://schemas.microsoft.com/office/drawing/2014/main" id="{71FC749F-44BE-4696-497C-E5758935A202}"/>
                  </a:ext>
                </a:extLst>
              </p:cNvPr>
              <p:cNvSpPr/>
              <p:nvPr/>
            </p:nvSpPr>
            <p:spPr>
              <a:xfrm rot="3460676">
                <a:off x="2438847" y="1272633"/>
                <a:ext cx="661695" cy="518344"/>
              </a:xfrm>
              <a:prstGeom prst="arc">
                <a:avLst/>
              </a:prstGeom>
              <a:ln>
                <a:solidFill>
                  <a:schemeClr val="tx1"/>
                </a:solidFill>
                <a:headEnd type="arrow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11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995472B9-D643-A3EF-8DA4-CA252D315E9A}"/>
                  </a:ext>
                </a:extLst>
              </p:cNvPr>
              <p:cNvSpPr txBox="1"/>
              <p:nvPr/>
            </p:nvSpPr>
            <p:spPr>
              <a:xfrm>
                <a:off x="3017512" y="1327936"/>
                <a:ext cx="39946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90</a:t>
                </a:r>
                <a:r>
                  <a:rPr lang="en-US" sz="11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o</a:t>
                </a:r>
              </a:p>
            </p:txBody>
          </p:sp>
        </p:grpSp>
        <p:sp>
          <p:nvSpPr>
            <p:cNvPr id="308" name="TextBox 307">
              <a:extLst>
                <a:ext uri="{FF2B5EF4-FFF2-40B4-BE49-F238E27FC236}">
                  <a16:creationId xmlns:a16="http://schemas.microsoft.com/office/drawing/2014/main" id="{DA77CD65-C53C-AB94-D18D-E70958DA1B78}"/>
                </a:ext>
              </a:extLst>
            </p:cNvPr>
            <p:cNvSpPr txBox="1"/>
            <p:nvPr/>
          </p:nvSpPr>
          <p:spPr>
            <a:xfrm>
              <a:off x="452383" y="927035"/>
              <a:ext cx="881973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Front Side</a:t>
              </a:r>
            </a:p>
            <a:p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9" name="TextBox 308">
              <a:extLst>
                <a:ext uri="{FF2B5EF4-FFF2-40B4-BE49-F238E27FC236}">
                  <a16:creationId xmlns:a16="http://schemas.microsoft.com/office/drawing/2014/main" id="{5843C707-0D3B-C5DC-73DB-800AFBE2A5FA}"/>
                </a:ext>
              </a:extLst>
            </p:cNvPr>
            <p:cNvSpPr txBox="1"/>
            <p:nvPr/>
          </p:nvSpPr>
          <p:spPr>
            <a:xfrm>
              <a:off x="3342137" y="954330"/>
              <a:ext cx="91319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Ventral</a:t>
              </a:r>
            </a:p>
          </p:txBody>
        </p:sp>
        <p:grpSp>
          <p:nvGrpSpPr>
            <p:cNvPr id="39" name="Group 38">
              <a:extLst>
                <a:ext uri="{FF2B5EF4-FFF2-40B4-BE49-F238E27FC236}">
                  <a16:creationId xmlns:a16="http://schemas.microsoft.com/office/drawing/2014/main" id="{9CE9D046-B1E7-2025-F3C5-D65126FC31F4}"/>
                </a:ext>
              </a:extLst>
            </p:cNvPr>
            <p:cNvGrpSpPr/>
            <p:nvPr/>
          </p:nvGrpSpPr>
          <p:grpSpPr>
            <a:xfrm>
              <a:off x="2971973" y="1365344"/>
              <a:ext cx="3589881" cy="2496574"/>
              <a:chOff x="1948734" y="1943207"/>
              <a:chExt cx="3429732" cy="2262208"/>
            </a:xfrm>
          </p:grpSpPr>
          <p:pic>
            <p:nvPicPr>
              <p:cNvPr id="301" name="Picture 300">
                <a:extLst>
                  <a:ext uri="{FF2B5EF4-FFF2-40B4-BE49-F238E27FC236}">
                    <a16:creationId xmlns:a16="http://schemas.microsoft.com/office/drawing/2014/main" id="{9F884720-2643-A687-9CD3-B04B346FB99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rcRect l="1691" r="1691"/>
              <a:stretch/>
            </p:blipFill>
            <p:spPr>
              <a:xfrm>
                <a:off x="2150347" y="1943207"/>
                <a:ext cx="3005540" cy="2262208"/>
              </a:xfrm>
              <a:prstGeom prst="rect">
                <a:avLst/>
              </a:prstGeom>
            </p:spPr>
          </p:pic>
          <p:sp>
            <p:nvSpPr>
              <p:cNvPr id="312" name="TextBox 311">
                <a:extLst>
                  <a:ext uri="{FF2B5EF4-FFF2-40B4-BE49-F238E27FC236}">
                    <a16:creationId xmlns:a16="http://schemas.microsoft.com/office/drawing/2014/main" id="{8C4852CE-0CEA-DE1E-6311-757A63D07D3C}"/>
                  </a:ext>
                </a:extLst>
              </p:cNvPr>
              <p:cNvSpPr txBox="1"/>
              <p:nvPr/>
            </p:nvSpPr>
            <p:spPr>
              <a:xfrm>
                <a:off x="1948734" y="3509422"/>
                <a:ext cx="731111" cy="23705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>
                    <a:solidFill>
                      <a:srgbClr val="3E3ECC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ead (I)</a:t>
                </a:r>
              </a:p>
            </p:txBody>
          </p:sp>
          <p:sp>
            <p:nvSpPr>
              <p:cNvPr id="313" name="TextBox 312">
                <a:extLst>
                  <a:ext uri="{FF2B5EF4-FFF2-40B4-BE49-F238E27FC236}">
                    <a16:creationId xmlns:a16="http://schemas.microsoft.com/office/drawing/2014/main" id="{84763A5C-3DCD-D349-07D7-B3893A72625C}"/>
                  </a:ext>
                </a:extLst>
              </p:cNvPr>
              <p:cNvSpPr txBox="1"/>
              <p:nvPr/>
            </p:nvSpPr>
            <p:spPr>
              <a:xfrm>
                <a:off x="4455306" y="3368726"/>
                <a:ext cx="923160" cy="23705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>
                    <a:solidFill>
                      <a:srgbClr val="E885E8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om VI</a:t>
                </a:r>
              </a:p>
            </p:txBody>
          </p:sp>
          <p:sp>
            <p:nvSpPr>
              <p:cNvPr id="314" name="TextBox 313">
                <a:extLst>
                  <a:ext uri="{FF2B5EF4-FFF2-40B4-BE49-F238E27FC236}">
                    <a16:creationId xmlns:a16="http://schemas.microsoft.com/office/drawing/2014/main" id="{55D928D9-F636-05D7-6138-A931757BDAB7}"/>
                  </a:ext>
                </a:extLst>
              </p:cNvPr>
              <p:cNvSpPr txBox="1"/>
              <p:nvPr/>
            </p:nvSpPr>
            <p:spPr>
              <a:xfrm>
                <a:off x="2636879" y="3773995"/>
                <a:ext cx="870181" cy="23705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>
                    <a:solidFill>
                      <a:srgbClr val="E32928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om V</a:t>
                </a:r>
              </a:p>
            </p:txBody>
          </p:sp>
          <p:sp>
            <p:nvSpPr>
              <p:cNvPr id="316" name="TextBox 315">
                <a:extLst>
                  <a:ext uri="{FF2B5EF4-FFF2-40B4-BE49-F238E27FC236}">
                    <a16:creationId xmlns:a16="http://schemas.microsoft.com/office/drawing/2014/main" id="{1A09C345-8EEA-12FA-4E11-0995403167F3}"/>
                  </a:ext>
                </a:extLst>
              </p:cNvPr>
              <p:cNvSpPr txBox="1"/>
              <p:nvPr/>
            </p:nvSpPr>
            <p:spPr>
              <a:xfrm>
                <a:off x="2138214" y="2108766"/>
                <a:ext cx="870181" cy="23705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>
                    <a:solidFill>
                      <a:srgbClr val="23E1E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eck (II)</a:t>
                </a:r>
              </a:p>
            </p:txBody>
          </p:sp>
          <p:sp>
            <p:nvSpPr>
              <p:cNvPr id="319" name="TextBox 318">
                <a:extLst>
                  <a:ext uri="{FF2B5EF4-FFF2-40B4-BE49-F238E27FC236}">
                    <a16:creationId xmlns:a16="http://schemas.microsoft.com/office/drawing/2014/main" id="{C54D62C0-E5F8-5968-567F-9D5C6AF0FE72}"/>
                  </a:ext>
                </a:extLst>
              </p:cNvPr>
              <p:cNvSpPr txBox="1"/>
              <p:nvPr/>
            </p:nvSpPr>
            <p:spPr>
              <a:xfrm>
                <a:off x="4455306" y="3750282"/>
                <a:ext cx="923160" cy="23705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>
                    <a:solidFill>
                      <a:srgbClr val="E88625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om IV</a:t>
                </a:r>
              </a:p>
            </p:txBody>
          </p:sp>
          <p:sp>
            <p:nvSpPr>
              <p:cNvPr id="96" name="TextBox 95">
                <a:extLst>
                  <a:ext uri="{FF2B5EF4-FFF2-40B4-BE49-F238E27FC236}">
                    <a16:creationId xmlns:a16="http://schemas.microsoft.com/office/drawing/2014/main" id="{6DAF11FE-5295-3639-D966-8807744E8244}"/>
                  </a:ext>
                </a:extLst>
              </p:cNvPr>
              <p:cNvSpPr txBox="1"/>
              <p:nvPr/>
            </p:nvSpPr>
            <p:spPr>
              <a:xfrm>
                <a:off x="4422030" y="2264284"/>
                <a:ext cx="837069" cy="23705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>
                    <a:solidFill>
                      <a:srgbClr val="30923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oop I</a:t>
                </a:r>
              </a:p>
            </p:txBody>
          </p:sp>
          <p:sp>
            <p:nvSpPr>
              <p:cNvPr id="315" name="TextBox 314">
                <a:extLst>
                  <a:ext uri="{FF2B5EF4-FFF2-40B4-BE49-F238E27FC236}">
                    <a16:creationId xmlns:a16="http://schemas.microsoft.com/office/drawing/2014/main" id="{8804784A-D8E6-F10B-F5C7-0BBF87657E47}"/>
                  </a:ext>
                </a:extLst>
              </p:cNvPr>
              <p:cNvSpPr txBox="1"/>
              <p:nvPr/>
            </p:nvSpPr>
            <p:spPr>
              <a:xfrm>
                <a:off x="3393665" y="1943208"/>
                <a:ext cx="898878" cy="23705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>
                    <a:solidFill>
                      <a:srgbClr val="00C5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om III</a:t>
                </a:r>
              </a:p>
            </p:txBody>
          </p:sp>
        </p:grpSp>
        <p:cxnSp>
          <p:nvCxnSpPr>
            <p:cNvPr id="28" name="Straight Connector 27">
              <a:extLst>
                <a:ext uri="{FF2B5EF4-FFF2-40B4-BE49-F238E27FC236}">
                  <a16:creationId xmlns:a16="http://schemas.microsoft.com/office/drawing/2014/main" id="{3016AA99-8D19-4D18-C8EC-8FFCEEE60F3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09271" y="-1042945"/>
              <a:ext cx="0" cy="178522"/>
            </a:xfrm>
            <a:prstGeom prst="line">
              <a:avLst/>
            </a:prstGeom>
            <a:ln>
              <a:solidFill>
                <a:srgbClr val="FF0000"/>
              </a:solidFill>
              <a:headEnd type="oval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>
              <a:extLst>
                <a:ext uri="{FF2B5EF4-FFF2-40B4-BE49-F238E27FC236}">
                  <a16:creationId xmlns:a16="http://schemas.microsoft.com/office/drawing/2014/main" id="{E675A46B-E11D-6026-12EE-BB543C2326F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460155" y="-1042945"/>
              <a:ext cx="0" cy="178522"/>
            </a:xfrm>
            <a:prstGeom prst="line">
              <a:avLst/>
            </a:prstGeom>
            <a:ln>
              <a:solidFill>
                <a:srgbClr val="FF0000"/>
              </a:solidFill>
              <a:headEnd type="oval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Connector 30">
              <a:extLst>
                <a:ext uri="{FF2B5EF4-FFF2-40B4-BE49-F238E27FC236}">
                  <a16:creationId xmlns:a16="http://schemas.microsoft.com/office/drawing/2014/main" id="{5DBFC459-C430-88E3-2885-A5787DB2552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379048" y="-1042945"/>
              <a:ext cx="0" cy="178522"/>
            </a:xfrm>
            <a:prstGeom prst="line">
              <a:avLst/>
            </a:prstGeom>
            <a:ln>
              <a:solidFill>
                <a:srgbClr val="3E3ECC"/>
              </a:solidFill>
              <a:headEnd type="oval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5636EFB9-73E1-BEE6-56ED-67563B932BA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815500" y="-1042945"/>
              <a:ext cx="0" cy="178522"/>
            </a:xfrm>
            <a:prstGeom prst="line">
              <a:avLst/>
            </a:prstGeom>
            <a:ln>
              <a:solidFill>
                <a:srgbClr val="3E3ECC"/>
              </a:solidFill>
              <a:headEnd type="oval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" name="Straight Connector 3">
              <a:extLst>
                <a:ext uri="{FF2B5EF4-FFF2-40B4-BE49-F238E27FC236}">
                  <a16:creationId xmlns:a16="http://schemas.microsoft.com/office/drawing/2014/main" id="{E258E4FD-7C5B-AC95-FF39-8D1214490772}"/>
                </a:ext>
              </a:extLst>
            </p:cNvPr>
            <p:cNvCxnSpPr>
              <a:cxnSpLocks/>
            </p:cNvCxnSpPr>
            <p:nvPr/>
          </p:nvCxnSpPr>
          <p:spPr>
            <a:xfrm>
              <a:off x="566915" y="-1061430"/>
              <a:ext cx="5180892" cy="0"/>
            </a:xfrm>
            <a:prstGeom prst="line">
              <a:avLst/>
            </a:prstGeom>
            <a:ln w="19050">
              <a:solidFill>
                <a:schemeClr val="accent3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9FF45205-30D5-C8F4-1E91-FFF76DF86BE3}"/>
                </a:ext>
              </a:extLst>
            </p:cNvPr>
            <p:cNvSpPr/>
            <p:nvPr/>
          </p:nvSpPr>
          <p:spPr>
            <a:xfrm>
              <a:off x="539892" y="-1189265"/>
              <a:ext cx="75318" cy="215301"/>
            </a:xfrm>
            <a:prstGeom prst="rect">
              <a:avLst/>
            </a:prstGeom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E6ED3F63-53C4-27C7-0B00-CBB95C81217A}"/>
                </a:ext>
              </a:extLst>
            </p:cNvPr>
            <p:cNvSpPr/>
            <p:nvPr/>
          </p:nvSpPr>
          <p:spPr>
            <a:xfrm>
              <a:off x="5624484" y="-1169080"/>
              <a:ext cx="75318" cy="195115"/>
            </a:xfrm>
            <a:prstGeom prst="rect">
              <a:avLst/>
            </a:prstGeom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3" name="Rectangle: Rounded Corners 12">
              <a:extLst>
                <a:ext uri="{FF2B5EF4-FFF2-40B4-BE49-F238E27FC236}">
                  <a16:creationId xmlns:a16="http://schemas.microsoft.com/office/drawing/2014/main" id="{2878A7A2-EF5B-89E4-2BF6-23C0A590F250}"/>
                </a:ext>
              </a:extLst>
            </p:cNvPr>
            <p:cNvSpPr/>
            <p:nvPr/>
          </p:nvSpPr>
          <p:spPr>
            <a:xfrm>
              <a:off x="678050" y="-1165307"/>
              <a:ext cx="422505" cy="182881"/>
            </a:xfrm>
            <a:prstGeom prst="roundRect">
              <a:avLst/>
            </a:prstGeom>
            <a:solidFill>
              <a:srgbClr val="3E3ECC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</a:p>
          </p:txBody>
        </p:sp>
        <p:sp>
          <p:nvSpPr>
            <p:cNvPr id="15" name="Rectangle: Rounded Corners 14">
              <a:extLst>
                <a:ext uri="{FF2B5EF4-FFF2-40B4-BE49-F238E27FC236}">
                  <a16:creationId xmlns:a16="http://schemas.microsoft.com/office/drawing/2014/main" id="{3C8D21AE-CFCF-C749-B7EF-B3BA67C88178}"/>
                </a:ext>
              </a:extLst>
            </p:cNvPr>
            <p:cNvSpPr/>
            <p:nvPr/>
          </p:nvSpPr>
          <p:spPr>
            <a:xfrm>
              <a:off x="1104645" y="-1165307"/>
              <a:ext cx="684100" cy="182881"/>
            </a:xfrm>
            <a:prstGeom prst="roundRect">
              <a:avLst/>
            </a:prstGeom>
            <a:solidFill>
              <a:srgbClr val="23E1E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I</a:t>
              </a:r>
            </a:p>
          </p:txBody>
        </p:sp>
        <p:sp>
          <p:nvSpPr>
            <p:cNvPr id="16" name="Rectangle: Rounded Corners 15">
              <a:extLst>
                <a:ext uri="{FF2B5EF4-FFF2-40B4-BE49-F238E27FC236}">
                  <a16:creationId xmlns:a16="http://schemas.microsoft.com/office/drawing/2014/main" id="{05C50599-638C-8C74-DB15-9176CA39770C}"/>
                </a:ext>
              </a:extLst>
            </p:cNvPr>
            <p:cNvSpPr/>
            <p:nvPr/>
          </p:nvSpPr>
          <p:spPr>
            <a:xfrm>
              <a:off x="1788746" y="-1165307"/>
              <a:ext cx="843559" cy="182881"/>
            </a:xfrm>
            <a:prstGeom prst="roundRect">
              <a:avLst/>
            </a:prstGeom>
            <a:solidFill>
              <a:srgbClr val="33CC33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II</a:t>
              </a:r>
            </a:p>
          </p:txBody>
        </p:sp>
        <p:sp>
          <p:nvSpPr>
            <p:cNvPr id="17" name="Rectangle: Rounded Corners 16">
              <a:extLst>
                <a:ext uri="{FF2B5EF4-FFF2-40B4-BE49-F238E27FC236}">
                  <a16:creationId xmlns:a16="http://schemas.microsoft.com/office/drawing/2014/main" id="{0624FF8E-775B-AF87-D21E-A27BDF33B448}"/>
                </a:ext>
              </a:extLst>
            </p:cNvPr>
            <p:cNvSpPr/>
            <p:nvPr/>
          </p:nvSpPr>
          <p:spPr>
            <a:xfrm>
              <a:off x="2623704" y="-1165307"/>
              <a:ext cx="684100" cy="182881"/>
            </a:xfrm>
            <a:prstGeom prst="roundRect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V</a:t>
              </a:r>
            </a:p>
          </p:txBody>
        </p:sp>
        <p:sp>
          <p:nvSpPr>
            <p:cNvPr id="18" name="Rectangle: Rounded Corners 17">
              <a:extLst>
                <a:ext uri="{FF2B5EF4-FFF2-40B4-BE49-F238E27FC236}">
                  <a16:creationId xmlns:a16="http://schemas.microsoft.com/office/drawing/2014/main" id="{69501779-9026-1E2C-72FA-5D1176E45E0A}"/>
                </a:ext>
              </a:extLst>
            </p:cNvPr>
            <p:cNvSpPr/>
            <p:nvPr/>
          </p:nvSpPr>
          <p:spPr>
            <a:xfrm>
              <a:off x="3302149" y="-1165307"/>
              <a:ext cx="416685" cy="182881"/>
            </a:xfrm>
            <a:prstGeom prst="roundRect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9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RI</a:t>
              </a:r>
            </a:p>
          </p:txBody>
        </p:sp>
        <p:sp>
          <p:nvSpPr>
            <p:cNvPr id="19" name="Rectangle: Rounded Corners 18">
              <a:extLst>
                <a:ext uri="{FF2B5EF4-FFF2-40B4-BE49-F238E27FC236}">
                  <a16:creationId xmlns:a16="http://schemas.microsoft.com/office/drawing/2014/main" id="{606E61A0-7C41-114C-9D2E-F3F9650FC833}"/>
                </a:ext>
              </a:extLst>
            </p:cNvPr>
            <p:cNvSpPr/>
            <p:nvPr/>
          </p:nvSpPr>
          <p:spPr>
            <a:xfrm>
              <a:off x="3719258" y="-1165307"/>
              <a:ext cx="121089" cy="182881"/>
            </a:xfrm>
            <a:prstGeom prst="roundRect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Rectangle: Rounded Corners 19">
              <a:extLst>
                <a:ext uri="{FF2B5EF4-FFF2-40B4-BE49-F238E27FC236}">
                  <a16:creationId xmlns:a16="http://schemas.microsoft.com/office/drawing/2014/main" id="{5F8CC20F-F59A-C8F3-5187-D15C33A36462}"/>
                </a:ext>
              </a:extLst>
            </p:cNvPr>
            <p:cNvSpPr/>
            <p:nvPr/>
          </p:nvSpPr>
          <p:spPr>
            <a:xfrm>
              <a:off x="3840354" y="-1163127"/>
              <a:ext cx="168101" cy="178522"/>
            </a:xfrm>
            <a:prstGeom prst="roundRect">
              <a:avLst/>
            </a:prstGeom>
            <a:solidFill>
              <a:srgbClr val="33CC33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Rectangle: Rounded Corners 20">
              <a:extLst>
                <a:ext uri="{FF2B5EF4-FFF2-40B4-BE49-F238E27FC236}">
                  <a16:creationId xmlns:a16="http://schemas.microsoft.com/office/drawing/2014/main" id="{788BAC48-302A-FBC1-56FE-F70CD40CB90E}"/>
                </a:ext>
              </a:extLst>
            </p:cNvPr>
            <p:cNvSpPr/>
            <p:nvPr/>
          </p:nvSpPr>
          <p:spPr>
            <a:xfrm>
              <a:off x="3970611" y="-1165308"/>
              <a:ext cx="982559" cy="182883"/>
            </a:xfrm>
            <a:prstGeom prst="round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</a:t>
              </a:r>
            </a:p>
          </p:txBody>
        </p:sp>
        <p:sp>
          <p:nvSpPr>
            <p:cNvPr id="22" name="Rectangle: Rounded Corners 21">
              <a:extLst>
                <a:ext uri="{FF2B5EF4-FFF2-40B4-BE49-F238E27FC236}">
                  <a16:creationId xmlns:a16="http://schemas.microsoft.com/office/drawing/2014/main" id="{A38A0A95-AC10-BA09-13BF-B5A01D97AFA2}"/>
                </a:ext>
              </a:extLst>
            </p:cNvPr>
            <p:cNvSpPr/>
            <p:nvPr/>
          </p:nvSpPr>
          <p:spPr>
            <a:xfrm>
              <a:off x="4948993" y="-1165308"/>
              <a:ext cx="591731" cy="182883"/>
            </a:xfrm>
            <a:prstGeom prst="roundRect">
              <a:avLst/>
            </a:prstGeom>
            <a:solidFill>
              <a:srgbClr val="E885E8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I</a:t>
              </a:r>
            </a:p>
          </p:txBody>
        </p: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A4897AA0-70D5-9B89-2431-80837C132FCA}"/>
                </a:ext>
              </a:extLst>
            </p:cNvPr>
            <p:cNvSpPr/>
            <p:nvPr/>
          </p:nvSpPr>
          <p:spPr>
            <a:xfrm>
              <a:off x="521200" y="-1005227"/>
              <a:ext cx="4833374" cy="23083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30          163               351                    595             780       899 931 972                      1246</a:t>
              </a:r>
            </a:p>
          </p:txBody>
        </p:sp>
        <p:pic>
          <p:nvPicPr>
            <p:cNvPr id="2" name="Content Placeholder 5" descr="A colorful cluster of small objects&#10;&#10;Description automatically generated with medium confidence">
              <a:extLst>
                <a:ext uri="{FF2B5EF4-FFF2-40B4-BE49-F238E27FC236}">
                  <a16:creationId xmlns:a16="http://schemas.microsoft.com/office/drawing/2014/main" id="{1390BB59-6CF3-D459-05F3-73876B00D47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451" t="24224" r="20566" b="24273"/>
            <a:stretch/>
          </p:blipFill>
          <p:spPr>
            <a:xfrm>
              <a:off x="-144570" y="1364218"/>
              <a:ext cx="2923085" cy="2214459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274872F4-3EE6-E41E-6339-EE49855BE465}"/>
                </a:ext>
              </a:extLst>
            </p:cNvPr>
            <p:cNvSpPr txBox="1"/>
            <p:nvPr/>
          </p:nvSpPr>
          <p:spPr>
            <a:xfrm>
              <a:off x="115223" y="3613882"/>
              <a:ext cx="6213658" cy="60016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Met rich insertion</a:t>
              </a:r>
              <a:r>
                <a:rPr lang="en-US" sz="1100" dirty="0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: G</a:t>
              </a:r>
              <a:r>
                <a:rPr lang="en-US" sz="1100" dirty="0">
                  <a:highlight>
                    <a:srgbClr val="FFFF00"/>
                  </a:highlight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MM</a:t>
              </a:r>
              <a:r>
                <a:rPr lang="en-US" sz="1100" dirty="0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A</a:t>
              </a:r>
              <a:r>
                <a:rPr lang="en-US" sz="1100" dirty="0">
                  <a:highlight>
                    <a:srgbClr val="FFFF00"/>
                  </a:highlight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MMM</a:t>
              </a:r>
              <a:r>
                <a:rPr lang="en-US" sz="1100" dirty="0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AAAAKKDQADNEPSGNGHPASAK</a:t>
              </a:r>
              <a:r>
                <a:rPr lang="en-US" sz="1100" dirty="0">
                  <a:highlight>
                    <a:srgbClr val="FFFF00"/>
                  </a:highlight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M</a:t>
              </a:r>
              <a:r>
                <a:rPr lang="en-US" sz="1100" dirty="0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EKGPHGK</a:t>
              </a:r>
              <a:r>
                <a:rPr lang="en-US" sz="1100" dirty="0">
                  <a:highlight>
                    <a:srgbClr val="FFFF00"/>
                  </a:highlight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M</a:t>
              </a:r>
              <a:r>
                <a:rPr lang="en-US" sz="1100" dirty="0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PAG</a:t>
              </a:r>
              <a:r>
                <a:rPr lang="en-US" sz="1100" dirty="0">
                  <a:highlight>
                    <a:srgbClr val="FFFF00"/>
                  </a:highlight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M</a:t>
              </a:r>
              <a:r>
                <a:rPr lang="en-US" sz="1100" dirty="0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KEAMKK</a:t>
              </a:r>
              <a:r>
                <a:rPr lang="en-US" sz="1100" dirty="0">
                  <a:highlight>
                    <a:srgbClr val="FFFF00"/>
                  </a:highlight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M</a:t>
              </a:r>
              <a:r>
                <a:rPr lang="en-US" sz="1100" dirty="0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GANMDPEKA</a:t>
              </a:r>
              <a:r>
                <a:rPr lang="en-US" sz="1100" dirty="0">
                  <a:highlight>
                    <a:srgbClr val="FFFF00"/>
                  </a:highlight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M</a:t>
              </a:r>
              <a:r>
                <a:rPr lang="en-US" sz="1100" dirty="0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E</a:t>
              </a:r>
              <a:r>
                <a:rPr lang="en-US" sz="1100" dirty="0">
                  <a:highlight>
                    <a:srgbClr val="FFFF00"/>
                  </a:highlight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M</a:t>
              </a:r>
              <a:r>
                <a:rPr lang="en-US" sz="1100" dirty="0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AKS</a:t>
              </a:r>
              <a:r>
                <a:rPr lang="en-US" sz="1100" dirty="0">
                  <a:highlight>
                    <a:srgbClr val="FFFF00"/>
                  </a:highlight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M</a:t>
              </a:r>
              <a:r>
                <a:rPr lang="en-US" sz="1100" dirty="0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GASPEALKK</a:t>
              </a:r>
              <a:r>
                <a:rPr lang="en-US" sz="1100" dirty="0">
                  <a:highlight>
                    <a:srgbClr val="FFFF00"/>
                  </a:highlight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M</a:t>
              </a:r>
              <a:r>
                <a:rPr lang="en-US" sz="1100" dirty="0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EAS</a:t>
              </a:r>
              <a:r>
                <a:rPr lang="en-US" sz="1100" dirty="0">
                  <a:highlight>
                    <a:srgbClr val="FFFF00"/>
                  </a:highlight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M</a:t>
              </a:r>
              <a:r>
                <a:rPr lang="en-US" sz="1100" dirty="0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KANKDTSTDASGKPA</a:t>
              </a:r>
              <a:r>
                <a:rPr lang="en-US" sz="1100" dirty="0">
                  <a:highlight>
                    <a:srgbClr val="FFFF00"/>
                  </a:highlight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M</a:t>
              </a:r>
              <a:r>
                <a:rPr lang="en-US" sz="1100" dirty="0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AGKTEKPQG</a:t>
              </a:r>
              <a:r>
                <a:rPr lang="en-US" sz="1100" dirty="0">
                  <a:highlight>
                    <a:srgbClr val="FFFF00"/>
                  </a:highlight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M</a:t>
              </a:r>
              <a:r>
                <a:rPr lang="en-US" sz="1100" dirty="0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SA</a:t>
              </a:r>
              <a:r>
                <a:rPr lang="en-US" sz="1100" dirty="0">
                  <a:highlight>
                    <a:srgbClr val="FFFF00"/>
                  </a:highlight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MM</a:t>
              </a:r>
              <a:r>
                <a:rPr lang="en-US" sz="1100" dirty="0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AA</a:t>
              </a:r>
              <a:r>
                <a:rPr lang="en-US" sz="1100" dirty="0">
                  <a:highlight>
                    <a:srgbClr val="FFFF00"/>
                  </a:highlight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M</a:t>
              </a:r>
              <a:r>
                <a:rPr lang="en-US" sz="1100" dirty="0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GKAPKE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41D682D8-362F-1D04-30CC-3CACFC8F486F}"/>
                </a:ext>
              </a:extLst>
            </p:cNvPr>
            <p:cNvSpPr txBox="1"/>
            <p:nvPr/>
          </p:nvSpPr>
          <p:spPr>
            <a:xfrm>
              <a:off x="268134" y="3385585"/>
              <a:ext cx="26169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Dorsal</a:t>
              </a:r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FC644567-78EA-D902-5F6F-32FC32F97967}"/>
                </a:ext>
              </a:extLst>
            </p:cNvPr>
            <p:cNvSpPr/>
            <p:nvPr/>
          </p:nvSpPr>
          <p:spPr>
            <a:xfrm>
              <a:off x="-15336" y="1323999"/>
              <a:ext cx="271228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4C0432D2-7156-E734-EA46-EA5DD0CFD4F1}"/>
                </a:ext>
              </a:extLst>
            </p:cNvPr>
            <p:cNvSpPr/>
            <p:nvPr/>
          </p:nvSpPr>
          <p:spPr>
            <a:xfrm>
              <a:off x="3349399" y="1323999"/>
              <a:ext cx="271228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828A8075-827D-3E7D-0B0B-3CEB5290B39E}"/>
                </a:ext>
              </a:extLst>
            </p:cNvPr>
            <p:cNvGrpSpPr/>
            <p:nvPr/>
          </p:nvGrpSpPr>
          <p:grpSpPr>
            <a:xfrm>
              <a:off x="2387401" y="1898742"/>
              <a:ext cx="978181" cy="661695"/>
              <a:chOff x="2510523" y="1200957"/>
              <a:chExt cx="978181" cy="661695"/>
            </a:xfrm>
          </p:grpSpPr>
          <p:cxnSp>
            <p:nvCxnSpPr>
              <p:cNvPr id="26" name="Straight Connector 25">
                <a:extLst>
                  <a:ext uri="{FF2B5EF4-FFF2-40B4-BE49-F238E27FC236}">
                    <a16:creationId xmlns:a16="http://schemas.microsoft.com/office/drawing/2014/main" id="{73AB27C2-B4E7-3FF9-3EE9-14420879071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867580" y="1574157"/>
                <a:ext cx="41190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" name="Arc 26">
                <a:extLst>
                  <a:ext uri="{FF2B5EF4-FFF2-40B4-BE49-F238E27FC236}">
                    <a16:creationId xmlns:a16="http://schemas.microsoft.com/office/drawing/2014/main" id="{428F0D6F-2A4F-CBE4-F085-B2EA20A7CB0E}"/>
                  </a:ext>
                </a:extLst>
              </p:cNvPr>
              <p:cNvSpPr/>
              <p:nvPr/>
            </p:nvSpPr>
            <p:spPr>
              <a:xfrm rot="3460676">
                <a:off x="2438847" y="1272633"/>
                <a:ext cx="661695" cy="518344"/>
              </a:xfrm>
              <a:prstGeom prst="arc">
                <a:avLst/>
              </a:prstGeom>
              <a:ln>
                <a:solidFill>
                  <a:schemeClr val="tx1"/>
                </a:solidFill>
                <a:headEnd type="arrow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11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CF54E702-F886-A1F1-BD23-9ED40467D29E}"/>
                  </a:ext>
                </a:extLst>
              </p:cNvPr>
              <p:cNvSpPr txBox="1"/>
              <p:nvPr/>
            </p:nvSpPr>
            <p:spPr>
              <a:xfrm>
                <a:off x="3010688" y="1327936"/>
                <a:ext cx="47801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80</a:t>
                </a:r>
                <a:r>
                  <a:rPr lang="en-US" sz="11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o</a:t>
                </a:r>
              </a:p>
            </p:txBody>
          </p:sp>
        </p:grpSp>
        <p:cxnSp>
          <p:nvCxnSpPr>
            <p:cNvPr id="34" name="Straight Connector 33">
              <a:extLst>
                <a:ext uri="{FF2B5EF4-FFF2-40B4-BE49-F238E27FC236}">
                  <a16:creationId xmlns:a16="http://schemas.microsoft.com/office/drawing/2014/main" id="{FF44BE52-8907-F0BC-9FC3-8F8C979418C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076503" y="2038139"/>
              <a:ext cx="508266" cy="485896"/>
            </a:xfrm>
            <a:prstGeom prst="line">
              <a:avLst/>
            </a:prstGeom>
            <a:ln w="38100">
              <a:solidFill>
                <a:schemeClr val="bg2">
                  <a:lumMod val="50000"/>
                </a:schemeClr>
              </a:solidFill>
              <a:tailEnd type="oval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id="{9205EBFE-EF1C-CE19-CCBC-A717978929A1}"/>
                </a:ext>
              </a:extLst>
            </p:cNvPr>
            <p:cNvSpPr/>
            <p:nvPr/>
          </p:nvSpPr>
          <p:spPr>
            <a:xfrm>
              <a:off x="584" y="3591808"/>
              <a:ext cx="231154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6454003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webextensions/_rels/taskpanes.xml.rels><?xml version="1.0" encoding="UTF-8" standalone="yes"?>
<Relationships xmlns="http://schemas.openxmlformats.org/package/2006/relationships"><Relationship Id="rId1" Type="http://schemas.microsoft.com/office/2011/relationships/webextension" Target="webextension1.xml"/></Relationships>
</file>

<file path=ppt/webextensions/taskpanes.xml><?xml version="1.0" encoding="utf-8"?>
<wetp:taskpanes xmlns:wetp="http://schemas.microsoft.com/office/webextensions/taskpanes/2010/11">
  <wetp:taskpane dockstate="right" visibility="0" width="700" row="0">
    <wetp:webextensionref xmlns:r="http://schemas.openxmlformats.org/officeDocument/2006/relationships" r:id="rId1"/>
  </wetp:taskpane>
</wetp:taskpanes>
</file>

<file path=ppt/webextensions/webextension1.xml><?xml version="1.0" encoding="utf-8"?>
<we:webextension xmlns:we="http://schemas.microsoft.com/office/webextensions/webextension/2010/11" id="{86F778CA-B289-4ED1-8832-C59F898FD5B2}">
  <we:reference id="wa200006038" version="1.0.0.3" store="en-US" storeType="OMEX"/>
  <we:alternateReferences>
    <we:reference id="wa200006038" version="1.0.0.3" store="" storeType="OMEX"/>
  </we:alternateReferences>
  <we:properties/>
  <we:bindings/>
  <we:snapshot xmlns:r="http://schemas.openxmlformats.org/officeDocument/2006/relationships"/>
</we:webextension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EFE575491624AB478B4D7E4E41CDEDFF" ma:contentTypeVersion="18" ma:contentTypeDescription="Create a new document." ma:contentTypeScope="" ma:versionID="8ef4ff8999dc2e52535599d1c047f972">
  <xsd:schema xmlns:xsd="http://www.w3.org/2001/XMLSchema" xmlns:xs="http://www.w3.org/2001/XMLSchema" xmlns:p="http://schemas.microsoft.com/office/2006/metadata/properties" xmlns:ns2="8d8b9b82-87f8-4d38-a474-60ce13ed8db9" xmlns:ns3="7cbebcc7-c4f1-4358-9fbf-2885dbb4de4a" targetNamespace="http://schemas.microsoft.com/office/2006/metadata/properties" ma:root="true" ma:fieldsID="1ee2ccf9ffefdcc6cbfb6b2aa66d2423" ns2:_="" ns3:_="">
    <xsd:import namespace="8d8b9b82-87f8-4d38-a474-60ce13ed8db9"/>
    <xsd:import namespace="7cbebcc7-c4f1-4358-9fbf-2885dbb4de4a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AutoTags" minOccurs="0"/>
                <xsd:element ref="ns2:MediaLengthInSeconds" minOccurs="0"/>
                <xsd:element ref="ns2:MediaServiceGenerationTime" minOccurs="0"/>
                <xsd:element ref="ns2:MediaServiceEventHashCode" minOccurs="0"/>
                <xsd:element ref="ns2:MediaServiceOCR" minOccurs="0"/>
                <xsd:element ref="ns2:MediaServiceDateTaken" minOccurs="0"/>
                <xsd:element ref="ns3:SharedWithUsers" minOccurs="0"/>
                <xsd:element ref="ns3:SharedWithDetails" minOccurs="0"/>
                <xsd:element ref="ns2:lcf76f155ced4ddcb4097134ff3c332f" minOccurs="0"/>
                <xsd:element ref="ns3:TaxCatchAll" minOccurs="0"/>
                <xsd:element ref="ns2:MediaServiceLocation" minOccurs="0"/>
                <xsd:element ref="ns2:MediaServiceObjectDetectorVersion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d8b9b82-87f8-4d38-a474-60ce13ed8db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LengthInSeconds" ma:index="13" nillable="true" ma:displayName="MediaLengthInSeconds" ma:hidden="true" ma:internalName="MediaLengthInSeconds" ma:readOnly="true">
      <xsd:simpleType>
        <xsd:restriction base="dms:Unknown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7" nillable="true" ma:displayName="MediaServiceDateTaken" ma:hidden="true" ma:internalName="MediaServiceDateTaken" ma:readOnly="true">
      <xsd:simpleType>
        <xsd:restriction base="dms:Text"/>
      </xsd:simpleType>
    </xsd:element>
    <xsd:element name="lcf76f155ced4ddcb4097134ff3c332f" ma:index="21" nillable="true" ma:taxonomy="true" ma:internalName="lcf76f155ced4ddcb4097134ff3c332f" ma:taxonomyFieldName="MediaServiceImageTags" ma:displayName="Image Tags" ma:readOnly="false" ma:fieldId="{5cf76f15-5ced-4ddc-b409-7134ff3c332f}" ma:taxonomyMulti="true" ma:sspId="c66bcfc7-c51b-4bc8-8383-b8f609394d6e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Location" ma:index="23" nillable="true" ma:displayName="Location" ma:description="" ma:indexed="true" ma:internalName="MediaServiceLocation" ma:readOnly="true">
      <xsd:simpleType>
        <xsd:restriction base="dms:Text"/>
      </xsd:simpleType>
    </xsd:element>
    <xsd:element name="MediaServiceObjectDetectorVersions" ma:index="24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5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cbebcc7-c4f1-4358-9fbf-2885dbb4de4a" elementFormDefault="qualified">
    <xsd:import namespace="http://schemas.microsoft.com/office/2006/documentManagement/types"/>
    <xsd:import namespace="http://schemas.microsoft.com/office/infopath/2007/PartnerControls"/>
    <xsd:element name="SharedWithUsers" ma:index="1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2" nillable="true" ma:displayName="Taxonomy Catch All Column" ma:hidden="true" ma:list="{bb1b61c4-1e43-4db5-acea-8bd320a75541}" ma:internalName="TaxCatchAll" ma:showField="CatchAllData" ma:web="7cbebcc7-c4f1-4358-9fbf-2885dbb4de4a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8d8b9b82-87f8-4d38-a474-60ce13ed8db9">
      <Terms xmlns="http://schemas.microsoft.com/office/infopath/2007/PartnerControls"/>
    </lcf76f155ced4ddcb4097134ff3c332f>
    <TaxCatchAll xmlns="7cbebcc7-c4f1-4358-9fbf-2885dbb4de4a" xsi:nil="true"/>
  </documentManagement>
</p:properties>
</file>

<file path=customXml/itemProps1.xml><?xml version="1.0" encoding="utf-8"?>
<ds:datastoreItem xmlns:ds="http://schemas.openxmlformats.org/officeDocument/2006/customXml" ds:itemID="{5C002F57-176E-49CB-93CB-89F8E0C2FA38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8d8b9b82-87f8-4d38-a474-60ce13ed8db9"/>
    <ds:schemaRef ds:uri="7cbebcc7-c4f1-4358-9fbf-2885dbb4de4a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BFC41ED1-EC55-414D-83E1-22E56BA41DBC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92E282F7-0FC2-4B84-B285-D57CD491FC70}">
  <ds:schemaRefs>
    <ds:schemaRef ds:uri="http://purl.org/dc/elements/1.1/"/>
    <ds:schemaRef ds:uri="http://schemas.microsoft.com/office/2006/metadata/properties"/>
    <ds:schemaRef ds:uri="7cbebcc7-c4f1-4358-9fbf-2885dbb4de4a"/>
    <ds:schemaRef ds:uri="http://schemas.microsoft.com/office/2006/documentManagement/types"/>
    <ds:schemaRef ds:uri="http://schemas.openxmlformats.org/package/2006/metadata/core-properties"/>
    <ds:schemaRef ds:uri="http://purl.org/dc/terms/"/>
    <ds:schemaRef ds:uri="http://schemas.microsoft.com/office/infopath/2007/PartnerControls"/>
    <ds:schemaRef ds:uri="http://purl.org/dc/dcmitype/"/>
    <ds:schemaRef ds:uri="8d8b9b82-87f8-4d38-a474-60ce13ed8db9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7039</TotalTime>
  <Words>52</Words>
  <Application>Microsoft Office PowerPoint</Application>
  <PresentationFormat>Custom</PresentationFormat>
  <Paragraphs>2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ss hartman</dc:creator>
  <cp:lastModifiedBy>Lawrence, C Martin</cp:lastModifiedBy>
  <cp:revision>187</cp:revision>
  <cp:lastPrinted>2024-08-29T22:50:57Z</cp:lastPrinted>
  <dcterms:created xsi:type="dcterms:W3CDTF">2019-04-04T22:12:04Z</dcterms:created>
  <dcterms:modified xsi:type="dcterms:W3CDTF">2025-07-09T14:24:5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FE575491624AB478B4D7E4E41CDEDFF</vt:lpwstr>
  </property>
  <property fmtid="{D5CDD505-2E9C-101B-9397-08002B2CF9AE}" pid="3" name="Order">
    <vt:r8>500</vt:r8>
  </property>
  <property fmtid="{D5CDD505-2E9C-101B-9397-08002B2CF9AE}" pid="4" name="MediaServiceImageTags">
    <vt:lpwstr/>
  </property>
</Properties>
</file>